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4" r:id="rId5"/>
    <p:sldId id="265" r:id="rId6"/>
    <p:sldId id="266" r:id="rId7"/>
    <p:sldId id="267" r:id="rId8"/>
    <p:sldId id="268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9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99BD73-A4A6-4A49-852C-67B32C2A01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BE8A56B-60E0-405D-9EAD-87AB193BA0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49FADC9-DEEF-4F6C-AF12-F8468000E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E7F3A10-97CA-4207-92D1-6482E2F59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80EBA76-A3C7-4E2F-9570-4A5611ABB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112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2BB096-AA84-420D-ADEB-3E44B4D94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D7330AB-AF1C-4264-B233-C4B7876F44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5FD1459-CC29-4A86-84F3-1A367645D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ECF49D8-A836-4C71-B236-8D04E9CD9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C8D5DD0-CAAD-4B56-A5A6-BAEBB3686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558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A47B4864-6807-44B8-9A78-B4FC5863B5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24977A1-9381-42B0-A003-27CA77ACBF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A9E3F27-B5E0-4FFA-A7CC-8BE84C567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E8F9DB4-51FC-4A4C-A195-A35AEC904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DA5D743-571C-4699-9A3C-C0A490FE5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827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ACDFDB2-E83C-43C2-BE97-1A59FB258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BFFFFAE-3DE2-49E8-9D15-EF772F591F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B486E86-F54B-4DCC-ABE9-61E52437F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481218B-83A0-41DA-9293-FF75A4740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57B9BE6-E407-4CBF-99B9-63168533B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7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0680C49-E63D-45B2-8BD6-352B3C64D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01DBA57-0ED9-4AA5-B221-A3D64A904F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853CF02-69EA-4B01-917D-33FC60BDE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1176313-0488-4F0F-8976-95FA4A525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828D81F-A810-41D9-899B-5B88DDEDB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962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BCC012-D7C1-4145-A1A9-EBEF55B11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74D3D0B-A2B1-46DA-8DC9-45CF243D4A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65F500B-8CF1-43AE-A03A-E23F7E4927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7F4997D-D37C-4786-BB99-3B4606EB0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B4DE8C9-0F1D-4339-B757-D35BEB016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15AC915-409A-4DE4-B856-F5DE06598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15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1281287-A407-4977-B701-A78BCD49E1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8FD2A0D-1AD4-4DFB-835E-E94D830F3F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EADB051-AF69-460C-896B-C678A45CAF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666EF6AF-919C-42E2-9D71-6FB4346757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9F657625-C7E8-48AC-B7BF-50C6F34A87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1F50569-9D90-4392-A2C5-4C931D544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7C5F003-1BB4-479D-A22E-068711CD4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EBF3BF2-A5A1-4001-985B-97A5837AB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51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681BC1-95C3-42E8-BA0F-FD1716669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7F98178-C356-400F-A414-19FB28D97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C3ACCC2B-120E-4197-AEB1-AA1279A3F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38BB1018-F6E7-4807-B118-8E3FB9F86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713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8B3C6FA2-A2FB-4A58-B756-359466080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A5469574-97F9-40A3-B4D5-C224A9516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AC45B7C-DF92-480D-A67F-C89E71E5F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407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6BD7EE-FCFB-45A4-BBFF-FD4F726EC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072375B-4F92-4AC4-B156-3D32CE9E2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97C01E0-B822-4DB7-9A13-C393D0D92F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A911B0-73AA-463A-9102-BC7574F99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D698911-B196-4F52-8F90-6C546C811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385F8EF-4124-408D-931E-EFA5E6091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757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7F21456-C7F9-4973-997D-AE9F9800B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EF8BACA-9FDF-432B-BED6-F112F19FFE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BE4B9FA-1645-4058-B2ED-DD9F3965EA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9E657E6-A366-46F8-A0A2-01ADC2D9E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1ED7345-878C-4566-AED4-3D9A36383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F7AE753-165E-4725-A9E2-F50461BC1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849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5FEE3DC3-BE17-4DDE-997B-C7FC0F8E34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F863A0A-044E-40F7-BD3A-B0459BFBE5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4E81745-3D7C-4B91-9F44-A9E2E3BF2F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52E6F-42CE-48F2-B45F-79D839C42E47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B5F640C-4483-4330-AE02-85B16E4747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248E39F-38EE-4056-A510-1EA35273D7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2067C-2CF0-4AC2-A2F2-C51E93C74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001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EDE7A80-302F-424F-A6C1-1884B5D43C10}"/>
              </a:ext>
            </a:extLst>
          </p:cNvPr>
          <p:cNvSpPr txBox="1"/>
          <p:nvPr/>
        </p:nvSpPr>
        <p:spPr>
          <a:xfrm>
            <a:off x="1497736" y="5988586"/>
            <a:ext cx="7218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1. </a:t>
            </a:r>
            <a:r>
              <a:rPr lang="en-US" dirty="0"/>
              <a:t>Full-length images of Western blot </a:t>
            </a:r>
            <a:r>
              <a:rPr lang="en-US" dirty="0" smtClean="0"/>
              <a:t>gels. </a:t>
            </a:r>
            <a:endParaRPr lang="en-US" dirty="0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xmlns="" id="{AC540DE8-9E02-4DB2-BE90-4183D269CF9C}"/>
              </a:ext>
            </a:extLst>
          </p:cNvPr>
          <p:cNvGrpSpPr/>
          <p:nvPr/>
        </p:nvGrpSpPr>
        <p:grpSpPr>
          <a:xfrm>
            <a:off x="1613068" y="869412"/>
            <a:ext cx="5002695" cy="4297250"/>
            <a:chOff x="1489973" y="148427"/>
            <a:chExt cx="5002695" cy="429725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A4490A05-7930-4E26-AF89-A082ED58F208}"/>
                </a:ext>
              </a:extLst>
            </p:cNvPr>
            <p:cNvSpPr txBox="1"/>
            <p:nvPr/>
          </p:nvSpPr>
          <p:spPr>
            <a:xfrm rot="16200000">
              <a:off x="1235052" y="864429"/>
              <a:ext cx="8899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10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4F28C9CF-4CEB-466E-86D5-EA5BEE148397}"/>
                </a:ext>
              </a:extLst>
            </p:cNvPr>
            <p:cNvSpPr txBox="1"/>
            <p:nvPr/>
          </p:nvSpPr>
          <p:spPr>
            <a:xfrm rot="16200000">
              <a:off x="1630302" y="975838"/>
              <a:ext cx="6671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7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47978BEF-8776-4A49-BF9C-74F938D10551}"/>
                </a:ext>
              </a:extLst>
            </p:cNvPr>
            <p:cNvSpPr txBox="1"/>
            <p:nvPr/>
          </p:nvSpPr>
          <p:spPr>
            <a:xfrm rot="16200000">
              <a:off x="1982715" y="642251"/>
              <a:ext cx="13261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DA-MB-23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C1E0DA3C-D32D-452E-AC48-E706D7676928}"/>
                </a:ext>
              </a:extLst>
            </p:cNvPr>
            <p:cNvSpPr txBox="1"/>
            <p:nvPr/>
          </p:nvSpPr>
          <p:spPr>
            <a:xfrm>
              <a:off x="1849322" y="4076345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9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0BD3165C-DD53-4D18-968B-D037CA1E3027}"/>
                </a:ext>
              </a:extLst>
            </p:cNvPr>
            <p:cNvSpPr txBox="1"/>
            <p:nvPr/>
          </p:nvSpPr>
          <p:spPr>
            <a:xfrm rot="16200000">
              <a:off x="3426801" y="876176"/>
              <a:ext cx="8899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10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B20E5272-E96D-4E88-B8FD-CDCA345F7B69}"/>
                </a:ext>
              </a:extLst>
            </p:cNvPr>
            <p:cNvSpPr txBox="1"/>
            <p:nvPr/>
          </p:nvSpPr>
          <p:spPr>
            <a:xfrm rot="16200000">
              <a:off x="3918352" y="987585"/>
              <a:ext cx="6671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7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91808848-C31C-4653-94AC-AAB18F2B3ECF}"/>
                </a:ext>
              </a:extLst>
            </p:cNvPr>
            <p:cNvSpPr txBox="1"/>
            <p:nvPr/>
          </p:nvSpPr>
          <p:spPr>
            <a:xfrm rot="16200000">
              <a:off x="3963634" y="642250"/>
              <a:ext cx="13261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DA-MB-23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E420A728-BFF6-480F-AF46-76AA4F657926}"/>
                </a:ext>
              </a:extLst>
            </p:cNvPr>
            <p:cNvSpPr txBox="1"/>
            <p:nvPr/>
          </p:nvSpPr>
          <p:spPr>
            <a:xfrm>
              <a:off x="3898038" y="4076345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6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FFB2A52B-AD2D-4EF5-85C7-C8103131101A}"/>
                </a:ext>
              </a:extLst>
            </p:cNvPr>
            <p:cNvSpPr txBox="1"/>
            <p:nvPr/>
          </p:nvSpPr>
          <p:spPr>
            <a:xfrm>
              <a:off x="5586920" y="4076345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8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09BA5834-E786-4A16-A8F1-9158F9E23ED7}"/>
                </a:ext>
              </a:extLst>
            </p:cNvPr>
            <p:cNvSpPr txBox="1"/>
            <p:nvPr/>
          </p:nvSpPr>
          <p:spPr>
            <a:xfrm rot="16200000">
              <a:off x="5123459" y="876175"/>
              <a:ext cx="8899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10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2BD31CA2-CA22-4161-B3A7-E31A3CB8ED16}"/>
                </a:ext>
              </a:extLst>
            </p:cNvPr>
            <p:cNvSpPr txBox="1"/>
            <p:nvPr/>
          </p:nvSpPr>
          <p:spPr>
            <a:xfrm rot="16200000">
              <a:off x="5615010" y="987584"/>
              <a:ext cx="6671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CF7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BE3FA1AC-DCFE-49C9-B6FC-EA27E8E3E768}"/>
                </a:ext>
              </a:extLst>
            </p:cNvPr>
            <p:cNvSpPr txBox="1"/>
            <p:nvPr/>
          </p:nvSpPr>
          <p:spPr>
            <a:xfrm rot="16200000">
              <a:off x="5660292" y="642249"/>
              <a:ext cx="13261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DA-MB-231</a:t>
              </a:r>
            </a:p>
          </p:txBody>
        </p:sp>
        <p:pic>
          <p:nvPicPr>
            <p:cNvPr id="34" name="Picture 33" descr="A picture containing text, electronics, white&#10;&#10;Description automatically generated">
              <a:extLst>
                <a:ext uri="{FF2B5EF4-FFF2-40B4-BE49-F238E27FC236}">
                  <a16:creationId xmlns:a16="http://schemas.microsoft.com/office/drawing/2014/main" xmlns="" id="{F436B5BB-21D5-41C1-8135-0D07EC2460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33" t="11162" r="31207"/>
            <a:stretch/>
          </p:blipFill>
          <p:spPr>
            <a:xfrm>
              <a:off x="1489973" y="1532581"/>
              <a:ext cx="718698" cy="2284942"/>
            </a:xfrm>
            <a:prstGeom prst="rect">
              <a:avLst/>
            </a:prstGeom>
          </p:spPr>
        </p:pic>
        <p:pic>
          <p:nvPicPr>
            <p:cNvPr id="35" name="Picture 34" descr="A picture containing old&#10;&#10;Description automatically generated">
              <a:extLst>
                <a:ext uri="{FF2B5EF4-FFF2-40B4-BE49-F238E27FC236}">
                  <a16:creationId xmlns:a16="http://schemas.microsoft.com/office/drawing/2014/main" xmlns="" id="{2EA4CFE2-DDE7-4757-A829-E5EC576035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74" r="20233" b="17320"/>
            <a:stretch/>
          </p:blipFill>
          <p:spPr>
            <a:xfrm>
              <a:off x="2290862" y="1532582"/>
              <a:ext cx="718698" cy="2284941"/>
            </a:xfrm>
            <a:prstGeom prst="rect">
              <a:avLst/>
            </a:prstGeom>
          </p:spPr>
        </p:pic>
        <p:pic>
          <p:nvPicPr>
            <p:cNvPr id="36" name="Picture 35" descr="A picture containing white&#10;&#10;Description automatically generated">
              <a:extLst>
                <a:ext uri="{FF2B5EF4-FFF2-40B4-BE49-F238E27FC236}">
                  <a16:creationId xmlns:a16="http://schemas.microsoft.com/office/drawing/2014/main" xmlns="" id="{A7BB347B-FD4E-4B1F-82C6-3FB072CC84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88" t="1811" r="50857"/>
            <a:stretch/>
          </p:blipFill>
          <p:spPr>
            <a:xfrm>
              <a:off x="3699185" y="1532581"/>
              <a:ext cx="1207915" cy="2284942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xmlns="" id="{75A0E3AF-09C7-4375-9E0D-62CCF07BD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25" r="44898" b="9897"/>
            <a:stretch/>
          </p:blipFill>
          <p:spPr>
            <a:xfrm>
              <a:off x="5443086" y="1532939"/>
              <a:ext cx="1033223" cy="23014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99679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F0E0128-438A-4FE1-B68E-EFB08641E6F2}"/>
              </a:ext>
            </a:extLst>
          </p:cNvPr>
          <p:cNvSpPr txBox="1"/>
          <p:nvPr/>
        </p:nvSpPr>
        <p:spPr>
          <a:xfrm>
            <a:off x="1966631" y="6177190"/>
            <a:ext cx="85169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2. </a:t>
            </a:r>
            <a:r>
              <a:rPr lang="en-US" dirty="0"/>
              <a:t>Venn diagrams presenting the overlap of </a:t>
            </a:r>
            <a:r>
              <a:rPr lang="en-US" dirty="0" err="1"/>
              <a:t>phosphopeptides</a:t>
            </a:r>
            <a:r>
              <a:rPr lang="en-US" dirty="0"/>
              <a:t> identified from either IMAC or TiO2 enrichment method using two fragmentation methods, CID and </a:t>
            </a:r>
            <a:r>
              <a:rPr lang="en-US" dirty="0" smtClean="0"/>
              <a:t>HCD.</a:t>
            </a:r>
            <a:endParaRPr lang="en-US" dirty="0"/>
          </a:p>
        </p:txBody>
      </p:sp>
      <p:pic>
        <p:nvPicPr>
          <p:cNvPr id="12" name="Picture 11" descr="Circle&#10;&#10;Description automatically generated with medium confidence">
            <a:extLst>
              <a:ext uri="{FF2B5EF4-FFF2-40B4-BE49-F238E27FC236}">
                <a16:creationId xmlns:a16="http://schemas.microsoft.com/office/drawing/2014/main" xmlns="" id="{1CDA7F65-8EC4-4787-8EDB-38DBD60B19D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794" y="-71223"/>
            <a:ext cx="5486411" cy="6248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4979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Whiteboard&#10;&#10;Description automatically generated with medium confidence">
            <a:extLst>
              <a:ext uri="{FF2B5EF4-FFF2-40B4-BE49-F238E27FC236}">
                <a16:creationId xmlns:a16="http://schemas.microsoft.com/office/drawing/2014/main" xmlns="" id="{203714C8-80C4-4DB7-A068-F6DD72E14F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6331" y="1109422"/>
            <a:ext cx="5943600" cy="42659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FEA2382-43D1-4EE4-9A36-FEEC01FE6080}"/>
              </a:ext>
            </a:extLst>
          </p:cNvPr>
          <p:cNvSpPr txBox="1"/>
          <p:nvPr/>
        </p:nvSpPr>
        <p:spPr>
          <a:xfrm>
            <a:off x="862539" y="5563912"/>
            <a:ext cx="9903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. </a:t>
            </a:r>
            <a:r>
              <a:rPr lang="en-US" dirty="0"/>
              <a:t>Phosphorylation motifs of EVs from MCF10A, MCF7, and MDA-MB-231 cells for </a:t>
            </a:r>
            <a:r>
              <a:rPr lang="en-US" dirty="0" err="1"/>
              <a:t>pS</a:t>
            </a:r>
            <a:r>
              <a:rPr lang="en-US" dirty="0"/>
              <a:t>, </a:t>
            </a:r>
            <a:r>
              <a:rPr lang="en-US" dirty="0" err="1"/>
              <a:t>pY</a:t>
            </a:r>
            <a:r>
              <a:rPr lang="en-US" dirty="0"/>
              <a:t>, and </a:t>
            </a:r>
            <a:r>
              <a:rPr lang="en-US" dirty="0" err="1" smtClean="0"/>
              <a:t>pY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6532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pie chart&#10;&#10;Description automatically generated">
            <a:extLst>
              <a:ext uri="{FF2B5EF4-FFF2-40B4-BE49-F238E27FC236}">
                <a16:creationId xmlns:a16="http://schemas.microsoft.com/office/drawing/2014/main" xmlns="" id="{63DC1116-8461-4148-948F-CAE6829505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8729" y="760562"/>
            <a:ext cx="6741339" cy="48334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CD45BFB-12AF-427D-B8C6-8081C220E3A1}"/>
              </a:ext>
            </a:extLst>
          </p:cNvPr>
          <p:cNvSpPr txBox="1"/>
          <p:nvPr/>
        </p:nvSpPr>
        <p:spPr>
          <a:xfrm>
            <a:off x="1035868" y="5573363"/>
            <a:ext cx="101202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4</a:t>
            </a:r>
            <a:r>
              <a:rPr lang="en-US" dirty="0"/>
              <a:t>.</a:t>
            </a:r>
            <a:r>
              <a:rPr lang="en-US" dirty="0" smtClean="0"/>
              <a:t> </a:t>
            </a:r>
            <a:r>
              <a:rPr lang="en-US" dirty="0"/>
              <a:t>Fractions of disease annotations for selected disease categories using phosphoproteins unique for MCF7 and MDA-MB-231 </a:t>
            </a:r>
            <a:r>
              <a:rPr lang="en-US" dirty="0" err="1" smtClean="0"/>
              <a:t>sEVs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94573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xmlns="" id="{D9014F2F-3AF2-46E8-8676-3E46EFF42831}"/>
              </a:ext>
            </a:extLst>
          </p:cNvPr>
          <p:cNvGrpSpPr/>
          <p:nvPr/>
        </p:nvGrpSpPr>
        <p:grpSpPr>
          <a:xfrm>
            <a:off x="0" y="-7199"/>
            <a:ext cx="12192000" cy="3203881"/>
            <a:chOff x="0" y="-7199"/>
            <a:chExt cx="12192000" cy="320388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4F6037D5-453A-43CF-AFCF-C44776A07C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468" t="14844" r="25351" b="34647"/>
            <a:stretch/>
          </p:blipFill>
          <p:spPr>
            <a:xfrm>
              <a:off x="0" y="0"/>
              <a:ext cx="6096000" cy="319668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48E0CA82-2CD4-4A13-8633-F0638D990B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469" t="14844" r="25351" b="34647"/>
            <a:stretch/>
          </p:blipFill>
          <p:spPr>
            <a:xfrm>
              <a:off x="0" y="0"/>
              <a:ext cx="6096000" cy="319668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9DF7617E-C29E-4D87-BE87-F55116D47E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0469" t="14844" r="25351" b="34647"/>
            <a:stretch/>
          </p:blipFill>
          <p:spPr>
            <a:xfrm>
              <a:off x="0" y="0"/>
              <a:ext cx="6096000" cy="319668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DBDD3964-84BA-4019-A393-AE1CFC5B61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0469" t="14844" r="25351" b="34647"/>
            <a:stretch/>
          </p:blipFill>
          <p:spPr>
            <a:xfrm>
              <a:off x="0" y="0"/>
              <a:ext cx="6096000" cy="319668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CC68B85D-3702-47C3-AF9B-6C5175F9E2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468" t="14844" r="25351" b="34647"/>
            <a:stretch/>
          </p:blipFill>
          <p:spPr>
            <a:xfrm>
              <a:off x="6096000" y="0"/>
              <a:ext cx="6096000" cy="319668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6A006C96-3BB1-4A5D-855E-CFCEC6C0BC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469" t="14844" r="25351" b="34647"/>
            <a:stretch/>
          </p:blipFill>
          <p:spPr>
            <a:xfrm>
              <a:off x="6096000" y="0"/>
              <a:ext cx="6096000" cy="319668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9DA654AC-BC80-4334-911E-B97B7538C9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0469" t="14844" r="25351" b="34647"/>
            <a:stretch/>
          </p:blipFill>
          <p:spPr>
            <a:xfrm>
              <a:off x="6096000" y="0"/>
              <a:ext cx="6096000" cy="319668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781FE022-8D0F-45B5-960B-7C6A28360C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2581" t="71217" r="53620" b="23015"/>
            <a:stretch/>
          </p:blipFill>
          <p:spPr>
            <a:xfrm>
              <a:off x="363220" y="364067"/>
              <a:ext cx="3446780" cy="46990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53345F33-4C60-4CBB-BA42-3E7298AA7D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2188" t="71217" r="63695" b="23015"/>
            <a:stretch/>
          </p:blipFill>
          <p:spPr>
            <a:xfrm>
              <a:off x="6631940" y="411478"/>
              <a:ext cx="2044700" cy="469901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658E24BD-0D88-4A33-A9F0-36D97CBA5F4F}"/>
                </a:ext>
              </a:extLst>
            </p:cNvPr>
            <p:cNvSpPr txBox="1"/>
            <p:nvPr/>
          </p:nvSpPr>
          <p:spPr>
            <a:xfrm>
              <a:off x="3716020" y="-7199"/>
              <a:ext cx="29159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ACLY (IMAC/HCD)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E803413-7FE8-40AC-9AE1-2A8BEB853ABA}"/>
              </a:ext>
            </a:extLst>
          </p:cNvPr>
          <p:cNvSpPr txBox="1"/>
          <p:nvPr/>
        </p:nvSpPr>
        <p:spPr>
          <a:xfrm>
            <a:off x="9812020" y="0"/>
            <a:ext cx="2915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PFKM (IMAC/HCD)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xmlns="" id="{3399973F-F34B-4A5A-A41C-3469AA1C47CD}"/>
              </a:ext>
            </a:extLst>
          </p:cNvPr>
          <p:cNvGrpSpPr/>
          <p:nvPr/>
        </p:nvGrpSpPr>
        <p:grpSpPr>
          <a:xfrm>
            <a:off x="0" y="3243719"/>
            <a:ext cx="12574483" cy="3329055"/>
            <a:chOff x="0" y="3528945"/>
            <a:chExt cx="12574483" cy="332905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529A0CF7-F97F-4E24-A649-CF97E94EF4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0565" t="14779" r="25394" b="34277"/>
            <a:stretch/>
          </p:blipFill>
          <p:spPr>
            <a:xfrm>
              <a:off x="6110068" y="3633020"/>
              <a:ext cx="6081932" cy="322498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F8D13575-17C2-4D7F-8B24-2FA5ED4C35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449" t="14648" r="25364" b="34061"/>
            <a:stretch/>
          </p:blipFill>
          <p:spPr>
            <a:xfrm>
              <a:off x="0" y="3618271"/>
              <a:ext cx="6084713" cy="323972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F452FDE7-106A-4747-8E69-2782538896D6}"/>
                </a:ext>
              </a:extLst>
            </p:cNvPr>
            <p:cNvSpPr txBox="1"/>
            <p:nvPr/>
          </p:nvSpPr>
          <p:spPr>
            <a:xfrm>
              <a:off x="9658563" y="3604219"/>
              <a:ext cx="29159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SIRT6 (IMAC/HCD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DA6C11DF-99CA-4450-8EE8-D8923923AD53}"/>
                </a:ext>
              </a:extLst>
            </p:cNvPr>
            <p:cNvSpPr txBox="1"/>
            <p:nvPr/>
          </p:nvSpPr>
          <p:spPr>
            <a:xfrm>
              <a:off x="3627530" y="3528945"/>
              <a:ext cx="29159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SIRT1 (IMAC/CID)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5A0A27D0-4207-4989-903F-C4AA5AE04C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449" t="71145" r="27752" b="23075"/>
            <a:stretch/>
          </p:blipFill>
          <p:spPr>
            <a:xfrm>
              <a:off x="336747" y="3823029"/>
              <a:ext cx="5376770" cy="337491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BA1A3BDC-776A-4753-92E0-5FB967298E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449" t="76947" r="72297" b="19083"/>
            <a:stretch/>
          </p:blipFill>
          <p:spPr>
            <a:xfrm>
              <a:off x="336747" y="4178299"/>
              <a:ext cx="752913" cy="231795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9C259CF6-A428-4D76-8580-C5BB0442AE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0565" t="71113" r="57028" b="22628"/>
            <a:stretch/>
          </p:blipFill>
          <p:spPr>
            <a:xfrm>
              <a:off x="6421460" y="4096076"/>
              <a:ext cx="2521728" cy="396240"/>
            </a:xfrm>
            <a:prstGeom prst="rect">
              <a:avLst/>
            </a:prstGeom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6CE6659-7AD1-490E-AAB8-0E8EC04A2443}"/>
              </a:ext>
            </a:extLst>
          </p:cNvPr>
          <p:cNvSpPr txBox="1"/>
          <p:nvPr/>
        </p:nvSpPr>
        <p:spPr>
          <a:xfrm>
            <a:off x="1342224" y="6493933"/>
            <a:ext cx="9274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5. </a:t>
            </a:r>
            <a:r>
              <a:rPr lang="en-US" dirty="0"/>
              <a:t>Representative MS/MS spectra of </a:t>
            </a:r>
            <a:r>
              <a:rPr lang="en-US" dirty="0" err="1"/>
              <a:t>phosphopeptides</a:t>
            </a:r>
            <a:r>
              <a:rPr lang="en-US" dirty="0"/>
              <a:t> from ACLY, PFKM, SIRT1, </a:t>
            </a:r>
            <a:r>
              <a:rPr lang="en-US"/>
              <a:t>and </a:t>
            </a:r>
            <a:r>
              <a:rPr lang="en-US" smtClean="0"/>
              <a:t>SIRT6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5659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180ED3FD598C43A09929F11264A7D0" ma:contentTypeVersion="4" ma:contentTypeDescription="Create a new document." ma:contentTypeScope="" ma:versionID="45cfc193e803cfb8fbac9a6a70215450">
  <xsd:schema xmlns:xsd="http://www.w3.org/2001/XMLSchema" xmlns:xs="http://www.w3.org/2001/XMLSchema" xmlns:p="http://schemas.microsoft.com/office/2006/metadata/properties" xmlns:ns3="f532022d-3127-4596-9fe0-52529fef03da" targetNamespace="http://schemas.microsoft.com/office/2006/metadata/properties" ma:root="true" ma:fieldsID="2e176cba4bee7501c03e5a06ab86b821" ns3:_="">
    <xsd:import namespace="f532022d-3127-4596-9fe0-52529fef03d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532022d-3127-4596-9fe0-52529fef03d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AFEFF95-A6C7-47F1-86F9-8DB530F726B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A9C25B1-4377-4859-9F04-651AF82C9CA3}">
  <ds:schemaRefs>
    <ds:schemaRef ds:uri="http://schemas.microsoft.com/office/infopath/2007/PartnerControls"/>
    <ds:schemaRef ds:uri="f532022d-3127-4596-9fe0-52529fef03da"/>
    <ds:schemaRef ds:uri="http://purl.org/dc/dcmitype/"/>
    <ds:schemaRef ds:uri="http://schemas.microsoft.com/office/2006/documentManagement/types"/>
    <ds:schemaRef ds:uri="http://schemas.openxmlformats.org/package/2006/metadata/core-properties"/>
    <ds:schemaRef ds:uri="http://purl.org/dc/terms/"/>
    <ds:schemaRef ds:uri="http://www.w3.org/XML/1998/namespace"/>
    <ds:schemaRef ds:uri="http://schemas.microsoft.com/office/2006/metadata/properties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86D6B9E8-51BA-4F1D-BE07-E8625EB48FF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532022d-3127-4596-9fe0-52529fef03d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126</Words>
  <Application>Microsoft Office PowerPoint</Application>
  <PresentationFormat>Widescreen</PresentationFormat>
  <Paragraphs>2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ran Minic</dc:creator>
  <cp:lastModifiedBy>MDPI</cp:lastModifiedBy>
  <cp:revision>25</cp:revision>
  <dcterms:created xsi:type="dcterms:W3CDTF">2021-12-01T23:08:01Z</dcterms:created>
  <dcterms:modified xsi:type="dcterms:W3CDTF">2022-02-09T09:4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180ED3FD598C43A09929F11264A7D0</vt:lpwstr>
  </property>
</Properties>
</file>